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60C89-8D15-4151-B5D4-68BE0A73CD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0A781-9F7B-41E0-AEA5-FF5D7188C8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30111-5CC2-4CDC-9BF3-97F7AF73B4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ECD46-6B68-411A-B62C-027F1AD9D7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EB4AB-7359-4AB9-8ADC-276E7901A6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D7192-7A34-41EC-B4CF-258C700430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C4775-53DD-48AA-9CA2-A674FE5082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FD691-2248-49DF-9FB8-7AA408C355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D1A54-1628-4ABA-A56F-F4AA918696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40624-FDE9-482F-97FC-8F650C1F5A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429A7-AB87-45BD-AAA8-F55056E070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E213F-417A-4533-A496-6304CD377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34CEE7-8531-49B0-90C2-7D0590ACB5D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838080" y="609480"/>
          <a:ext cx="7620120" cy="5191200"/>
        </p:xfrm>
        <a:graphic>
          <a:graphicData uri="http://schemas.openxmlformats.org/drawingml/2006/table">
            <a:tbl>
              <a:tblPr/>
              <a:tblGrid>
                <a:gridCol w="1067040"/>
                <a:gridCol w="228600"/>
                <a:gridCol w="380880"/>
                <a:gridCol w="228600"/>
                <a:gridCol w="380880"/>
                <a:gridCol w="228600"/>
                <a:gridCol w="381240"/>
                <a:gridCol w="228600"/>
                <a:gridCol w="380880"/>
                <a:gridCol w="228600"/>
                <a:gridCol w="380880"/>
                <a:gridCol w="228600"/>
                <a:gridCol w="381240"/>
                <a:gridCol w="228600"/>
                <a:gridCol w="228600"/>
                <a:gridCol w="228600"/>
                <a:gridCol w="380880"/>
                <a:gridCol w="228600"/>
                <a:gridCol w="380880"/>
                <a:gridCol w="228600"/>
                <a:gridCol w="381240"/>
                <a:gridCol w="228600"/>
                <a:gridCol w="380880"/>
              </a:tblGrid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ust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7468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O Ter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2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pid localization (GO:001087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20E-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50E-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pid transport (GO:000686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70E+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2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pid storage (GO:001991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0E-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edling development (GO:001991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5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50E-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ed oilbody biogenesis (GO:001991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70E-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mbryo development ending in seed dormancy (GO:000979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0E-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ed development (GO:00483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0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60E-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atty acid oxidation (GO:001939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6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70E-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llular lipid catabolic process (GO:004424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40E-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pid biosynthetic process (GO:000861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30E-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pid metabolic process (GO:000662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90E-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60E-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atty acid biosynthetic process (GO:0006633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30E-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1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4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atty acid metabolic process (GO:000663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40E-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otosynthesis (GO:001597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0E-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gnan metabolic process (GO:000980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2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27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gnan biosynthetic process (GO:0009807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50E-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3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tein metabolic process (GO:0019538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20E-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7T15:17:21Z</dcterms:created>
  <dc:creator>Tchagang, Alain</dc:creator>
  <dc:description/>
  <dc:language>en-US</dc:language>
  <cp:lastModifiedBy>Tchagang, Alain</cp:lastModifiedBy>
  <dcterms:modified xsi:type="dcterms:W3CDTF">2011-01-27T15:19:15Z</dcterms:modified>
  <cp:revision>1</cp:revision>
  <dc:subject/>
  <dc:title>Slide 1</dc:title>
</cp:coreProperties>
</file>